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F82E62-AEB4-C3F6-5374-8B5586415A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1ADDB0-6512-17DD-9779-B69D5D6421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9B7E4D-7B71-5894-0C74-B1C8E8EE7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CF697-6AC9-9448-BA10-ABD5CB65A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54C7F5-A5C6-9707-EE4F-DC813A5DD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719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720180-D6AF-E1F9-5690-1BB3ED00A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5E6883-2FE8-CC9F-DE42-D5263BCF20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6A59BC-F161-8908-0A47-3C6B2006F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9E893C-7863-CA74-6434-15D24EF38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02053F-9A39-E0F2-C3AC-83B77BC6F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237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277131-F9B3-76AE-F24C-D8CA36B619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763140-30BF-78F2-70EE-F281A12099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163855-F6A7-FE16-251D-76A5A6673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71175E-5FEE-D5F1-E0B8-348351155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A4B6E-E42C-56C3-4FE3-C234D6E48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023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9F08C-550B-22EE-F1BD-B83DC8C61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12A7F7-9627-6F5D-7A45-97CA0B558D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4B47AC-2263-F10A-847E-007214514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C360BD-7DE9-84A4-D43D-AB6871E33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7C15C-FC43-7E7B-1221-10E5C141B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224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DAD9F-F502-954A-E6B4-2EC025546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100E94-E020-DFE2-0268-8C204869B6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41CD11-7903-E413-5B34-4B581BD2D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6D0574-089A-0511-0448-246272E74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AB6289-1E53-B7C1-A192-35B9A32F4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659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45589-6C06-A8C2-6C6A-68B58B1C67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45AD87-5D90-0E1E-178D-BCE121A128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06115C-FDEC-D743-D3D1-2A4A730298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A60EB1-F924-B6B9-7783-00D12C5C4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B2A29E-98F9-8C50-DFFF-F6A2EEE76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F86C22-00B2-A6FB-900A-294B94785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957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A4126-EBAF-52F7-A8E2-26871E35B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65F70A-AD0D-4AB0-5C41-66A424592E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849563-75C0-265D-A96B-380991A02C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11BDEE-0C9B-C231-D13A-6D9EC65915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B4B37F-2EED-F15F-3526-22BB5CE652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FF7733-D879-4501-A4DB-36E07EA84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C68925-31E0-3B36-26C8-1E95EB409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58D3F4-6E3C-9306-1380-AF9CC6474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882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CEBD2-39E3-28BC-B160-160434192F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A40C1B-71C1-C30D-954F-7F9347DD1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F72F2B-7757-B310-268C-48A66786D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B4CF80-F7C9-35A3-45FE-7CC27F907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155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968133-9D05-6F4B-CF90-BBE541693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FD0FE9-68BB-4898-1B2B-964AD5936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99129D-CDD6-CA8E-E9BF-0D1DB7531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92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08CD3-0E9C-6B07-A552-78D07F4D04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9ED2E3-78E1-4DE1-B360-2BADC8C568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4371AC-8EC7-A027-48B7-A2E6CF0AAF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7A419C-C393-1F56-F8B8-48B28BFE8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22B32E-972A-6CA8-6A32-10BF66BD7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8E0946-B375-3333-5E6C-1F9F62094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673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A7E04-B5CD-64E3-158F-A19C97847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D34C2B-680D-5656-21B9-21C4C27D43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6631EC-44D4-097D-969C-739A17196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6C4B6C-B9D1-5A04-F3B5-BD6370D9A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75A57B-BD6A-3931-7912-7869CB2BA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13BF6A-2714-960D-2BCC-2F6EBC024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52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F52C39-DF95-F9F6-53A3-206DB3B425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C66338-6AF5-8159-6A01-8E5854F2B0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7E1C68-62A6-1165-F93B-5DB28A4C36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C1D74E-835D-474A-B232-9C54D96ED65A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F91026-ACB4-1E83-12D7-548C0B8668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02ABDF-4181-DADC-4F44-41ED002B75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4AF77F-E817-9F48-B474-B36224FEA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762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881102-3565-E9C6-8243-AD41B9A8A3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BD09AE-741D-D1A8-D5B8-2F6A96E804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9546" y="0"/>
            <a:ext cx="4252908" cy="57793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AB3A255-145D-41A5-F408-32017CA55A6B}"/>
              </a:ext>
            </a:extLst>
          </p:cNvPr>
          <p:cNvSpPr txBox="1"/>
          <p:nvPr/>
        </p:nvSpPr>
        <p:spPr>
          <a:xfrm>
            <a:off x="0" y="5779322"/>
            <a:ext cx="12192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 S2: Distribution of next-generation sequencing reads across the VL library variants after panning. 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A heatmap showing the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ercentage of all</a:t>
            </a:r>
            <a:r>
              <a:rPr lang="en-US" sz="18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reads belonging to the indicated hFlex3a2_v2 variant after two rounds of panning against </a:t>
            </a:r>
            <a:r>
              <a:rPr lang="en-US" sz="1800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 </a:t>
            </a:r>
            <a:r>
              <a:rPr lang="en-US" sz="18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.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4150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5:02Z</dcterms:created>
  <dcterms:modified xsi:type="dcterms:W3CDTF">2026-02-19T23:45:17Z</dcterms:modified>
</cp:coreProperties>
</file>